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335713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7D13F-85C1-4517-9D16-CB558728E6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ACD7A-9940-4484-AED3-46B97F15BA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4A6B2-F07C-4DB8-9023-E9ACDCF4A2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4568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7384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752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4568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7384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AA3F21-546D-4E5F-9638-5A4260513A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24B5D-CA81-429C-9BA4-4E7C41734D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DEE06-B006-4884-9402-2E2235BF8B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E11BA0-263C-43B1-9622-34A37D9C24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D8895-F459-46F6-A639-99F1801849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7520" y="396360"/>
            <a:ext cx="57024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185B2-C3C9-4349-9F1B-EA49987EDD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BF36F-56B3-4F24-9C63-50E07EF852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0D4C1-1287-4DE7-BDAA-7D8F565654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B1C86-F027-465D-A9FB-068D1EA79E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7160" y="9182160"/>
            <a:ext cx="1477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65400" y="9182160"/>
            <a:ext cx="200664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41760" y="9182160"/>
            <a:ext cx="14781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4E9603-025F-4595-8FD3-96B1FA6F93D6}" type="slidenum"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8"/>
          <p:cNvSpPr/>
          <p:nvPr/>
        </p:nvSpPr>
        <p:spPr>
          <a:xfrm rot="17531400">
            <a:off x="3334680" y="1009800"/>
            <a:ext cx="55620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8640" rIns="98640" tIns="49320" bIns="49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mo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18"/>
          <p:cNvSpPr/>
          <p:nvPr/>
        </p:nvSpPr>
        <p:spPr>
          <a:xfrm rot="17531400">
            <a:off x="4293360" y="956520"/>
            <a:ext cx="61704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8640" rIns="98640" tIns="49320" bIns="49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FAP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18"/>
          <p:cNvSpPr/>
          <p:nvPr/>
        </p:nvSpPr>
        <p:spPr>
          <a:xfrm rot="17531400">
            <a:off x="3772080" y="884520"/>
            <a:ext cx="77112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8640" rIns="98640" tIns="49320" bIns="49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FAP1L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20"/>
          <p:cNvSpPr/>
          <p:nvPr/>
        </p:nvSpPr>
        <p:spPr>
          <a:xfrm>
            <a:off x="4746600" y="1406520"/>
            <a:ext cx="113364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640" rIns="98640" tIns="49320" bIns="49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rc pY4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22"/>
          <p:cNvSpPr/>
          <p:nvPr/>
        </p:nvSpPr>
        <p:spPr>
          <a:xfrm>
            <a:off x="4746600" y="1797120"/>
            <a:ext cx="113364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640" rIns="98640" tIns="49320" bIns="49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r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23"/>
          <p:cNvSpPr/>
          <p:nvPr/>
        </p:nvSpPr>
        <p:spPr>
          <a:xfrm>
            <a:off x="4746600" y="2612880"/>
            <a:ext cx="113364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640" rIns="98640" tIns="49320" bIns="49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FAP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24"/>
          <p:cNvSpPr/>
          <p:nvPr/>
        </p:nvSpPr>
        <p:spPr>
          <a:xfrm>
            <a:off x="4746600" y="2992320"/>
            <a:ext cx="113364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640" rIns="98640" tIns="49320" bIns="49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CT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25"/>
          <p:cNvSpPr/>
          <p:nvPr/>
        </p:nvSpPr>
        <p:spPr>
          <a:xfrm>
            <a:off x="4746600" y="2195640"/>
            <a:ext cx="113364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640" rIns="98640" tIns="49320" bIns="49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FAP1L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直線コネクタ 10"/>
          <p:cNvSpPr/>
          <p:nvPr/>
        </p:nvSpPr>
        <p:spPr>
          <a:xfrm>
            <a:off x="3354480" y="652320"/>
            <a:ext cx="13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29"/>
          <p:cNvSpPr/>
          <p:nvPr/>
        </p:nvSpPr>
        <p:spPr>
          <a:xfrm>
            <a:off x="3471840" y="398520"/>
            <a:ext cx="1135080" cy="28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640" rIns="98640" tIns="49320" bIns="4932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RK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2" descr="K:\マイドキュメント（同期）\C7059\Western Blotting\130608 C7059 AFAP1 Src\130607 AFAP OE 2P3.bmp"/>
          <p:cNvPicPr/>
          <p:nvPr/>
        </p:nvPicPr>
        <p:blipFill>
          <a:blip r:embed="rId1"/>
          <a:srcRect l="0" t="8475" r="0" b="7288"/>
          <a:stretch/>
        </p:blipFill>
        <p:spPr>
          <a:xfrm>
            <a:off x="3306600" y="2136600"/>
            <a:ext cx="1440000" cy="358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2" name="Picture 3" descr="K:\マイドキュメント（同期）\C7059\Western Blotting\130608 C7059 AFAP1 Src\130607 AFAP OE ACTB.bmp"/>
          <p:cNvPicPr/>
          <p:nvPr/>
        </p:nvPicPr>
        <p:blipFill>
          <a:blip r:embed="rId2"/>
          <a:stretch/>
        </p:blipFill>
        <p:spPr>
          <a:xfrm>
            <a:off x="3306600" y="2970360"/>
            <a:ext cx="1440000" cy="299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3" name="Picture 4" descr="K:\マイドキュメント（同期）\C7059\Western Blotting\130608 C7059 AFAP1 Src\130607 AFAP OE AFAP1.bmp"/>
          <p:cNvPicPr/>
          <p:nvPr/>
        </p:nvPicPr>
        <p:blipFill>
          <a:blip r:embed="rId3"/>
          <a:stretch/>
        </p:blipFill>
        <p:spPr>
          <a:xfrm>
            <a:off x="3306600" y="2558880"/>
            <a:ext cx="1440000" cy="349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4" name="Picture 8" descr="K:\マイドキュメント（同期）\C7059\Western Blotting\130608 C7059 AFAP1 Src\130607 AFAP OE Src 2.bmp"/>
          <p:cNvPicPr/>
          <p:nvPr/>
        </p:nvPicPr>
        <p:blipFill>
          <a:blip r:embed="rId4"/>
          <a:stretch/>
        </p:blipFill>
        <p:spPr>
          <a:xfrm>
            <a:off x="3306600" y="1763640"/>
            <a:ext cx="1440000" cy="316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55" name="グループ化 80"/>
          <p:cNvGrpSpPr/>
          <p:nvPr/>
        </p:nvGrpSpPr>
        <p:grpSpPr>
          <a:xfrm>
            <a:off x="-49320" y="6997680"/>
            <a:ext cx="6267600" cy="2563920"/>
            <a:chOff x="-49320" y="6997680"/>
            <a:chExt cx="6267600" cy="2563920"/>
          </a:xfrm>
        </p:grpSpPr>
        <p:sp>
          <p:nvSpPr>
            <p:cNvPr id="56" name="テキスト ボックス 24"/>
            <p:cNvSpPr/>
            <p:nvPr/>
          </p:nvSpPr>
          <p:spPr>
            <a:xfrm>
              <a:off x="-49320" y="8034480"/>
              <a:ext cx="37620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テキスト ボックス 24"/>
            <p:cNvSpPr/>
            <p:nvPr/>
          </p:nvSpPr>
          <p:spPr>
            <a:xfrm>
              <a:off x="-49320" y="8982360"/>
              <a:ext cx="37620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4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テキスト ボックス 24"/>
            <p:cNvSpPr/>
            <p:nvPr/>
          </p:nvSpPr>
          <p:spPr>
            <a:xfrm>
              <a:off x="262440" y="7493760"/>
              <a:ext cx="94608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テキスト ボックス 25"/>
            <p:cNvSpPr/>
            <p:nvPr/>
          </p:nvSpPr>
          <p:spPr>
            <a:xfrm>
              <a:off x="1141200" y="7493760"/>
              <a:ext cx="107028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µM PP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テキスト ボックス 24"/>
            <p:cNvSpPr/>
            <p:nvPr/>
          </p:nvSpPr>
          <p:spPr>
            <a:xfrm>
              <a:off x="725400" y="7225560"/>
              <a:ext cx="971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arenta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1" name="Picture 29" descr="E:\マイドキュメント（同期）\C7059\論文draft\作業中\PP2 treatment representative figures\A2_PP2_4h.tif"/>
            <p:cNvPicPr/>
            <p:nvPr/>
          </p:nvPicPr>
          <p:blipFill>
            <a:blip r:embed="rId5"/>
            <a:stretch/>
          </p:blipFill>
          <p:spPr>
            <a:xfrm>
              <a:off x="5210280" y="866088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62" name="Picture 31" descr="E:\マイドキュメント（同期）\C7059\論文draft\作業中\PP2 treatment representative figures\A2_DMSO_4h.tif"/>
            <p:cNvPicPr/>
            <p:nvPr/>
          </p:nvPicPr>
          <p:blipFill>
            <a:blip r:embed="rId6"/>
            <a:stretch/>
          </p:blipFill>
          <p:spPr>
            <a:xfrm>
              <a:off x="4263120" y="866160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3" name="直線コネクタ 35"/>
            <p:cNvSpPr/>
            <p:nvPr/>
          </p:nvSpPr>
          <p:spPr>
            <a:xfrm>
              <a:off x="311040" y="7470720"/>
              <a:ext cx="180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テキスト ボックス 24"/>
            <p:cNvSpPr/>
            <p:nvPr/>
          </p:nvSpPr>
          <p:spPr>
            <a:xfrm>
              <a:off x="2268000" y="7493760"/>
              <a:ext cx="90000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テキスト ボックス 25"/>
            <p:cNvSpPr/>
            <p:nvPr/>
          </p:nvSpPr>
          <p:spPr>
            <a:xfrm>
              <a:off x="3096720" y="7493760"/>
              <a:ext cx="111636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µM PP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テキスト ボックス 24"/>
            <p:cNvSpPr/>
            <p:nvPr/>
          </p:nvSpPr>
          <p:spPr>
            <a:xfrm>
              <a:off x="2707920" y="7225560"/>
              <a:ext cx="971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LacZ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直線コネクタ 49"/>
            <p:cNvSpPr/>
            <p:nvPr/>
          </p:nvSpPr>
          <p:spPr>
            <a:xfrm>
              <a:off x="2293920" y="7470720"/>
              <a:ext cx="180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直線コネクタ 50"/>
            <p:cNvSpPr/>
            <p:nvPr/>
          </p:nvSpPr>
          <p:spPr>
            <a:xfrm>
              <a:off x="382320" y="7245360"/>
              <a:ext cx="561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テキスト ボックス 24"/>
            <p:cNvSpPr/>
            <p:nvPr/>
          </p:nvSpPr>
          <p:spPr>
            <a:xfrm>
              <a:off x="2725920" y="6997680"/>
              <a:ext cx="971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KO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" name="Picture 45" descr="E:\マイドキュメント（同期）\C7059\論文draft\作業中\PP2 treatment representative figures\Parental_DMSO_0h_2.tif"/>
            <p:cNvPicPr/>
            <p:nvPr/>
          </p:nvPicPr>
          <p:blipFill>
            <a:blip r:embed="rId7"/>
            <a:stretch/>
          </p:blipFill>
          <p:spPr>
            <a:xfrm>
              <a:off x="285840" y="771804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1" name="Picture 46" descr="E:\マイドキュメント（同期）\C7059\論文draft\作業中\PP2 treatment representative figures\Parental_DMSO_4h_2.tif"/>
            <p:cNvPicPr/>
            <p:nvPr/>
          </p:nvPicPr>
          <p:blipFill>
            <a:blip r:embed="rId8"/>
            <a:stretch/>
          </p:blipFill>
          <p:spPr>
            <a:xfrm>
              <a:off x="285840" y="866160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2" name="Picture 66" descr="E:\マイドキュメント（同期）\C7059\論文draft\作業中\PP2 treatment representative figures\LacZ_DMSO_0h.tif"/>
            <p:cNvPicPr/>
            <p:nvPr/>
          </p:nvPicPr>
          <p:blipFill>
            <a:blip r:embed="rId9"/>
            <a:stretch/>
          </p:blipFill>
          <p:spPr>
            <a:xfrm>
              <a:off x="2268000" y="771804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3" name="Picture 67" descr="E:\マイドキュメント（同期）\C7059\論文draft\作業中\PP2 treatment representative figures\LacZ_DMSO_4h.tif"/>
            <p:cNvPicPr/>
            <p:nvPr/>
          </p:nvPicPr>
          <p:blipFill>
            <a:blip r:embed="rId10"/>
            <a:stretch/>
          </p:blipFill>
          <p:spPr>
            <a:xfrm>
              <a:off x="2268000" y="866160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4" name="Picture 68" descr="E:\マイドキュメント（同期）\C7059\論文draft\作業中\PP2 treatment representative figures\LacZ_PP2_0h.tif"/>
            <p:cNvPicPr/>
            <p:nvPr/>
          </p:nvPicPr>
          <p:blipFill>
            <a:blip r:embed="rId11"/>
            <a:stretch/>
          </p:blipFill>
          <p:spPr>
            <a:xfrm>
              <a:off x="3214800" y="771804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5" name="Picture 69" descr="E:\マイドキュメント（同期）\C7059\論文draft\作業中\PP2 treatment representative figures\LacZ_PP2_4h.tif"/>
            <p:cNvPicPr/>
            <p:nvPr/>
          </p:nvPicPr>
          <p:blipFill>
            <a:blip r:embed="rId12"/>
            <a:stretch/>
          </p:blipFill>
          <p:spPr>
            <a:xfrm>
              <a:off x="3214800" y="866160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76" name="テキスト ボックス 24"/>
            <p:cNvSpPr/>
            <p:nvPr/>
          </p:nvSpPr>
          <p:spPr>
            <a:xfrm>
              <a:off x="4263120" y="7493760"/>
              <a:ext cx="90000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テキスト ボックス 25"/>
            <p:cNvSpPr/>
            <p:nvPr/>
          </p:nvSpPr>
          <p:spPr>
            <a:xfrm>
              <a:off x="5101920" y="7493760"/>
              <a:ext cx="111636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µM PP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テキスト ボックス 24"/>
            <p:cNvSpPr/>
            <p:nvPr/>
          </p:nvSpPr>
          <p:spPr>
            <a:xfrm>
              <a:off x="4694400" y="7225560"/>
              <a:ext cx="971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直線コネクタ 72"/>
            <p:cNvSpPr/>
            <p:nvPr/>
          </p:nvSpPr>
          <p:spPr>
            <a:xfrm>
              <a:off x="4280040" y="7470720"/>
              <a:ext cx="180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0" name="Picture 30" descr="E:\マイドキュメント（同期）\C7059\論文draft\作業中\PP2 treatment representative figures\A2_PP2_0h.tif"/>
            <p:cNvPicPr/>
            <p:nvPr/>
          </p:nvPicPr>
          <p:blipFill>
            <a:blip r:embed="rId13"/>
            <a:stretch/>
          </p:blipFill>
          <p:spPr>
            <a:xfrm>
              <a:off x="5210280" y="771804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1" name="Picture 32" descr="E:\マイドキュメント（同期）\C7059\論文draft\作業中\PP2 treatment representative figures\A2_DMSO_0h.tif"/>
            <p:cNvPicPr/>
            <p:nvPr/>
          </p:nvPicPr>
          <p:blipFill>
            <a:blip r:embed="rId14"/>
            <a:stretch/>
          </p:blipFill>
          <p:spPr>
            <a:xfrm>
              <a:off x="4263120" y="771804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2" name="Picture 70" descr="E:\マイドキュメント（同期）\C7059\論文draft\作業中\PP2 treatment representative figures\Parental_PP2_0h.tif"/>
            <p:cNvPicPr/>
            <p:nvPr/>
          </p:nvPicPr>
          <p:blipFill>
            <a:blip r:embed="rId15"/>
            <a:stretch/>
          </p:blipFill>
          <p:spPr>
            <a:xfrm>
              <a:off x="1226160" y="771804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3" name="Picture 71" descr="E:\マイドキュメント（同期）\C7059\論文draft\作業中\PP2 treatment representative figures\Parental_PP2_4h.tif"/>
            <p:cNvPicPr/>
            <p:nvPr/>
          </p:nvPicPr>
          <p:blipFill>
            <a:blip r:embed="rId16"/>
            <a:stretch/>
          </p:blipFill>
          <p:spPr>
            <a:xfrm>
              <a:off x="1226160" y="8661600"/>
              <a:ext cx="900000" cy="90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84" name="グループ化 94"/>
          <p:cNvGrpSpPr/>
          <p:nvPr/>
        </p:nvGrpSpPr>
        <p:grpSpPr>
          <a:xfrm>
            <a:off x="2833560" y="3657600"/>
            <a:ext cx="3503880" cy="3166920"/>
            <a:chOff x="2833560" y="3657600"/>
            <a:chExt cx="3503880" cy="3166920"/>
          </a:xfrm>
        </p:grpSpPr>
        <p:pic>
          <p:nvPicPr>
            <p:cNvPr id="85" name="グラフ 90" descr=""/>
            <p:cNvPicPr/>
            <p:nvPr/>
          </p:nvPicPr>
          <p:blipFill>
            <a:blip r:embed="rId17"/>
            <a:stretch/>
          </p:blipFill>
          <p:spPr>
            <a:xfrm>
              <a:off x="3017160" y="3657600"/>
              <a:ext cx="3320280" cy="3166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テキスト ボックス 29"/>
            <p:cNvSpPr/>
            <p:nvPr/>
          </p:nvSpPr>
          <p:spPr>
            <a:xfrm rot="16200000">
              <a:off x="2223720" y="4885920"/>
              <a:ext cx="1501200" cy="28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% Rounded Cel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" name="グループ化 93"/>
          <p:cNvGrpSpPr/>
          <p:nvPr/>
        </p:nvGrpSpPr>
        <p:grpSpPr>
          <a:xfrm>
            <a:off x="281160" y="393840"/>
            <a:ext cx="2560320" cy="2604960"/>
            <a:chOff x="281160" y="393840"/>
            <a:chExt cx="2560320" cy="2604960"/>
          </a:xfrm>
        </p:grpSpPr>
        <p:sp>
          <p:nvSpPr>
            <p:cNvPr id="88" name="テキスト ボックス 18"/>
            <p:cNvSpPr/>
            <p:nvPr/>
          </p:nvSpPr>
          <p:spPr>
            <a:xfrm rot="17531400">
              <a:off x="256680" y="909000"/>
              <a:ext cx="75276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arenta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テキスト ボックス 18"/>
            <p:cNvSpPr/>
            <p:nvPr/>
          </p:nvSpPr>
          <p:spPr>
            <a:xfrm rot="17531400">
              <a:off x="831240" y="1006560"/>
              <a:ext cx="49824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LacZ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テキスト ボックス 20"/>
            <p:cNvSpPr/>
            <p:nvPr/>
          </p:nvSpPr>
          <p:spPr>
            <a:xfrm>
              <a:off x="1707840" y="1423800"/>
              <a:ext cx="1133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rc pY41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テキスト ボックス 22"/>
            <p:cNvSpPr/>
            <p:nvPr/>
          </p:nvSpPr>
          <p:spPr>
            <a:xfrm>
              <a:off x="1707840" y="1828440"/>
              <a:ext cx="1133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r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テキスト ボックス 23"/>
            <p:cNvSpPr/>
            <p:nvPr/>
          </p:nvSpPr>
          <p:spPr>
            <a:xfrm>
              <a:off x="1708200" y="2666880"/>
              <a:ext cx="1133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CT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テキスト ボックス 25"/>
            <p:cNvSpPr/>
            <p:nvPr/>
          </p:nvSpPr>
          <p:spPr>
            <a:xfrm>
              <a:off x="1708200" y="2235240"/>
              <a:ext cx="1133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FAP1L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線コネクタ 108"/>
            <p:cNvSpPr/>
            <p:nvPr/>
          </p:nvSpPr>
          <p:spPr>
            <a:xfrm>
              <a:off x="322200" y="658800"/>
              <a:ext cx="14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テキスト ボックス 29"/>
            <p:cNvSpPr/>
            <p:nvPr/>
          </p:nvSpPr>
          <p:spPr>
            <a:xfrm>
              <a:off x="456840" y="393840"/>
              <a:ext cx="1135080" cy="28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K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テキスト ボックス 18"/>
            <p:cNvSpPr/>
            <p:nvPr/>
          </p:nvSpPr>
          <p:spPr>
            <a:xfrm rot="17531400">
              <a:off x="1297800" y="1072440"/>
              <a:ext cx="36864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7" name="Picture 74" descr="E:\マイドキュメント（同期）\C7059\Western Blotting\130614 RKO stable clones Src\130614 P Z A2 pSrc 2P3.bmp"/>
            <p:cNvPicPr/>
            <p:nvPr/>
          </p:nvPicPr>
          <p:blipFill>
            <a:blip r:embed="rId18"/>
            <a:stretch/>
          </p:blipFill>
          <p:spPr>
            <a:xfrm>
              <a:off x="281160" y="2189520"/>
              <a:ext cx="1440000" cy="359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8" name="Picture 75" descr="E:\マイドキュメント（同期）\C7059\Western Blotting\130614 RKO stable clones Src\130614 P Z A2 pSrc ACTB.bmp"/>
            <p:cNvPicPr/>
            <p:nvPr/>
          </p:nvPicPr>
          <p:blipFill>
            <a:blip r:embed="rId19"/>
            <a:stretch/>
          </p:blipFill>
          <p:spPr>
            <a:xfrm>
              <a:off x="281160" y="2603160"/>
              <a:ext cx="1440000" cy="395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9" name="Picture 76" descr="E:\マイドキュメント（同期）\C7059\Western Blotting\130614 RKO stable clones Src\130614 P Z A2 pSrc pY416.bmp"/>
            <p:cNvPicPr/>
            <p:nvPr/>
          </p:nvPicPr>
          <p:blipFill>
            <a:blip r:embed="rId20"/>
            <a:stretch/>
          </p:blipFill>
          <p:spPr>
            <a:xfrm>
              <a:off x="281160" y="1378800"/>
              <a:ext cx="1440000" cy="359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0" name="Picture 78" descr="E:\マイドキュメント（同期）\C7059\Western Blotting\130614 RKO stable clones Src\130614 P Z A2 pSrc Src.bmp"/>
            <p:cNvPicPr/>
            <p:nvPr/>
          </p:nvPicPr>
          <p:blipFill>
            <a:blip r:embed="rId21"/>
            <a:stretch/>
          </p:blipFill>
          <p:spPr>
            <a:xfrm>
              <a:off x="281160" y="1782360"/>
              <a:ext cx="1440000" cy="359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101" name="テキスト ボックス 141"/>
          <p:cNvSpPr/>
          <p:nvPr/>
        </p:nvSpPr>
        <p:spPr>
          <a:xfrm>
            <a:off x="-25560" y="0"/>
            <a:ext cx="176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ry Figure S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グループ化 82"/>
          <p:cNvGrpSpPr/>
          <p:nvPr/>
        </p:nvGrpSpPr>
        <p:grpSpPr>
          <a:xfrm>
            <a:off x="4608360" y="3951360"/>
            <a:ext cx="266760" cy="615960"/>
            <a:chOff x="4608360" y="3951360"/>
            <a:chExt cx="266760" cy="615960"/>
          </a:xfrm>
        </p:grpSpPr>
        <p:sp>
          <p:nvSpPr>
            <p:cNvPr id="103" name="直線コネクタ 78"/>
            <p:cNvSpPr/>
            <p:nvPr/>
          </p:nvSpPr>
          <p:spPr>
            <a:xfrm>
              <a:off x="4608360" y="3951360"/>
              <a:ext cx="1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直線コネクタ 79"/>
            <p:cNvSpPr/>
            <p:nvPr/>
          </p:nvSpPr>
          <p:spPr>
            <a:xfrm>
              <a:off x="4608360" y="4567320"/>
              <a:ext cx="1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線コネクタ 80"/>
            <p:cNvSpPr/>
            <p:nvPr/>
          </p:nvSpPr>
          <p:spPr>
            <a:xfrm>
              <a:off x="4716360" y="3951360"/>
              <a:ext cx="0" cy="61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テキスト ボックス 49"/>
            <p:cNvSpPr/>
            <p:nvPr/>
          </p:nvSpPr>
          <p:spPr>
            <a:xfrm rot="5400000">
              <a:off x="4626360" y="413388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7" name="グループ化 83"/>
          <p:cNvGrpSpPr/>
          <p:nvPr/>
        </p:nvGrpSpPr>
        <p:grpSpPr>
          <a:xfrm>
            <a:off x="4773600" y="5457960"/>
            <a:ext cx="266760" cy="395280"/>
            <a:chOff x="4773600" y="5457960"/>
            <a:chExt cx="266760" cy="395280"/>
          </a:xfrm>
        </p:grpSpPr>
        <p:sp>
          <p:nvSpPr>
            <p:cNvPr id="108" name="直線コネクタ 84"/>
            <p:cNvSpPr/>
            <p:nvPr/>
          </p:nvSpPr>
          <p:spPr>
            <a:xfrm>
              <a:off x="4773600" y="5457960"/>
              <a:ext cx="1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直線コネクタ 89"/>
            <p:cNvSpPr/>
            <p:nvPr/>
          </p:nvSpPr>
          <p:spPr>
            <a:xfrm>
              <a:off x="4773600" y="5853240"/>
              <a:ext cx="1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直線コネクタ 91"/>
            <p:cNvSpPr/>
            <p:nvPr/>
          </p:nvSpPr>
          <p:spPr>
            <a:xfrm>
              <a:off x="4881600" y="5457960"/>
              <a:ext cx="0" cy="39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テキスト ボックス 49"/>
            <p:cNvSpPr/>
            <p:nvPr/>
          </p:nvSpPr>
          <p:spPr>
            <a:xfrm rot="5400000">
              <a:off x="4791600" y="55310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2" name="グループ化 93"/>
          <p:cNvGrpSpPr/>
          <p:nvPr/>
        </p:nvGrpSpPr>
        <p:grpSpPr>
          <a:xfrm>
            <a:off x="4608360" y="5519160"/>
            <a:ext cx="266760" cy="250920"/>
            <a:chOff x="4608360" y="5519160"/>
            <a:chExt cx="266760" cy="250920"/>
          </a:xfrm>
        </p:grpSpPr>
        <p:sp>
          <p:nvSpPr>
            <p:cNvPr id="113" name="直線コネクタ 94"/>
            <p:cNvSpPr/>
            <p:nvPr/>
          </p:nvSpPr>
          <p:spPr>
            <a:xfrm>
              <a:off x="4608360" y="5537160"/>
              <a:ext cx="1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直線コネクタ 95"/>
            <p:cNvSpPr/>
            <p:nvPr/>
          </p:nvSpPr>
          <p:spPr>
            <a:xfrm>
              <a:off x="4608360" y="5753160"/>
              <a:ext cx="1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直線コネクタ 96"/>
            <p:cNvSpPr/>
            <p:nvPr/>
          </p:nvSpPr>
          <p:spPr>
            <a:xfrm>
              <a:off x="4716360" y="5537160"/>
              <a:ext cx="0" cy="21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テキスト ボックス 49"/>
            <p:cNvSpPr/>
            <p:nvPr/>
          </p:nvSpPr>
          <p:spPr>
            <a:xfrm rot="5400000">
              <a:off x="4626360" y="55213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テキスト ボックス 142"/>
          <p:cNvSpPr/>
          <p:nvPr/>
        </p:nvSpPr>
        <p:spPr>
          <a:xfrm>
            <a:off x="1440" y="298440"/>
            <a:ext cx="25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テキスト ボックス 142"/>
          <p:cNvSpPr/>
          <p:nvPr/>
        </p:nvSpPr>
        <p:spPr>
          <a:xfrm>
            <a:off x="3024000" y="29844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テキスト ボックス 142"/>
          <p:cNvSpPr/>
          <p:nvPr/>
        </p:nvSpPr>
        <p:spPr>
          <a:xfrm>
            <a:off x="6840" y="3443400"/>
            <a:ext cx="24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テキスト ボックス 142"/>
          <p:cNvSpPr/>
          <p:nvPr/>
        </p:nvSpPr>
        <p:spPr>
          <a:xfrm>
            <a:off x="3024000" y="344340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テキスト ボックス 142"/>
          <p:cNvSpPr/>
          <p:nvPr/>
        </p:nvSpPr>
        <p:spPr>
          <a:xfrm>
            <a:off x="2520" y="6859440"/>
            <a:ext cx="25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2" name="Picture 99" descr="K:\マイドキュメント（同期）\C7059\Western Blotting\130608 C7059 AFAP1 Src\130607 AFAP OE pY416 2.bmp"/>
          <p:cNvPicPr/>
          <p:nvPr/>
        </p:nvPicPr>
        <p:blipFill>
          <a:blip r:embed="rId22"/>
          <a:stretch/>
        </p:blipFill>
        <p:spPr>
          <a:xfrm>
            <a:off x="3306600" y="1368360"/>
            <a:ext cx="1440000" cy="344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123" name="グループ化 104"/>
          <p:cNvGrpSpPr/>
          <p:nvPr/>
        </p:nvGrpSpPr>
        <p:grpSpPr>
          <a:xfrm>
            <a:off x="235080" y="3624120"/>
            <a:ext cx="2933640" cy="1801800"/>
            <a:chOff x="235080" y="3624120"/>
            <a:chExt cx="2933640" cy="1801800"/>
          </a:xfrm>
        </p:grpSpPr>
        <p:sp>
          <p:nvSpPr>
            <p:cNvPr id="124" name="テキスト ボックス 20"/>
            <p:cNvSpPr/>
            <p:nvPr/>
          </p:nvSpPr>
          <p:spPr>
            <a:xfrm>
              <a:off x="2035440" y="4887720"/>
              <a:ext cx="1133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rc pY41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テキスト ボックス 22"/>
            <p:cNvSpPr/>
            <p:nvPr/>
          </p:nvSpPr>
          <p:spPr>
            <a:xfrm>
              <a:off x="2035440" y="5159520"/>
              <a:ext cx="113328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r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直線コネクタ 86"/>
            <p:cNvSpPr/>
            <p:nvPr/>
          </p:nvSpPr>
          <p:spPr>
            <a:xfrm>
              <a:off x="293760" y="4622760"/>
              <a:ext cx="5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テキスト ボックス 29"/>
            <p:cNvSpPr/>
            <p:nvPr/>
          </p:nvSpPr>
          <p:spPr>
            <a:xfrm>
              <a:off x="503280" y="3624120"/>
              <a:ext cx="1135080" cy="28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K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テキスト ボックス 18"/>
            <p:cNvSpPr/>
            <p:nvPr/>
          </p:nvSpPr>
          <p:spPr>
            <a:xfrm>
              <a:off x="2036160" y="4635720"/>
              <a:ext cx="79236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µM PP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テキスト ボックス 29"/>
            <p:cNvSpPr/>
            <p:nvPr/>
          </p:nvSpPr>
          <p:spPr>
            <a:xfrm rot="17775600">
              <a:off x="339840" y="4094280"/>
              <a:ext cx="723960" cy="43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Parenta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テキスト ボックス 18"/>
            <p:cNvSpPr/>
            <p:nvPr/>
          </p:nvSpPr>
          <p:spPr>
            <a:xfrm>
              <a:off x="274680" y="4635720"/>
              <a:ext cx="172728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+-+-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直線コネクタ 85"/>
            <p:cNvSpPr/>
            <p:nvPr/>
          </p:nvSpPr>
          <p:spPr>
            <a:xfrm>
              <a:off x="879480" y="4602240"/>
              <a:ext cx="50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直線コネクタ 87"/>
            <p:cNvSpPr/>
            <p:nvPr/>
          </p:nvSpPr>
          <p:spPr>
            <a:xfrm>
              <a:off x="1459080" y="4602240"/>
              <a:ext cx="50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テキスト ボックス 29"/>
            <p:cNvSpPr/>
            <p:nvPr/>
          </p:nvSpPr>
          <p:spPr>
            <a:xfrm rot="17775600">
              <a:off x="868320" y="4140720"/>
              <a:ext cx="72396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LacZ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テキスト ボックス 29"/>
            <p:cNvSpPr/>
            <p:nvPr/>
          </p:nvSpPr>
          <p:spPr>
            <a:xfrm rot="17775600">
              <a:off x="1443240" y="4140360"/>
              <a:ext cx="725760" cy="2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8640" rIns="98640" tIns="49320" bIns="4932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直線コネクタ 88"/>
            <p:cNvSpPr/>
            <p:nvPr/>
          </p:nvSpPr>
          <p:spPr>
            <a:xfrm>
              <a:off x="325440" y="3868560"/>
              <a:ext cx="1582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6" name="Picture 98" descr="K:\マイドキュメント（同期）\C7059\Western Blotting\130628 RKO PP2 total Src conditioning\130628 2ug 2.bmp"/>
            <p:cNvPicPr/>
            <p:nvPr/>
          </p:nvPicPr>
          <p:blipFill>
            <a:blip r:embed="rId23"/>
            <a:stretch/>
          </p:blipFill>
          <p:spPr>
            <a:xfrm>
              <a:off x="235080" y="5186520"/>
              <a:ext cx="1800360" cy="2142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37" name="Picture 99" descr="K:\マイドキュメント（同期）\C7059\Western Blotting\130702 PP2 pY416 final\130702 PP2 pY416 1.bmp"/>
            <p:cNvPicPr/>
            <p:nvPr/>
          </p:nvPicPr>
          <p:blipFill>
            <a:blip r:embed="rId24"/>
            <a:stretch/>
          </p:blipFill>
          <p:spPr>
            <a:xfrm>
              <a:off x="235080" y="4907520"/>
              <a:ext cx="1800000" cy="2300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10T07:50:08Z</dcterms:created>
  <dc:creator>Ryo　Takahashi</dc:creator>
  <dc:description/>
  <dc:language>en-US</dc:language>
  <cp:lastModifiedBy>戸口田 淳也</cp:lastModifiedBy>
  <dcterms:modified xsi:type="dcterms:W3CDTF">2013-09-16T07:19:59Z</dcterms:modified>
  <cp:revision>50</cp:revision>
  <dc:subject/>
  <dc:title>スライド 1</dc:title>
</cp:coreProperties>
</file>